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23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114BE5A3-0B0D-440B-9FD2-FFD4FA3EF737}"/>
    <pc:docChg chg="delSld">
      <pc:chgData name="Norgard,Dr.,Bobby (DR CI+IM) BIP-US-R" userId="8fb42a27-e12b-430d-ab3b-20c232fde4c7" providerId="ADAL" clId="{114BE5A3-0B0D-440B-9FD2-FFD4FA3EF737}" dt="2024-05-02T15:22:58.220" v="7" actId="47"/>
      <pc:docMkLst>
        <pc:docMk/>
      </pc:docMkLst>
      <pc:sldChg chg="del">
        <pc:chgData name="Norgard,Dr.,Bobby (DR CI+IM) BIP-US-R" userId="8fb42a27-e12b-430d-ab3b-20c232fde4c7" providerId="ADAL" clId="{114BE5A3-0B0D-440B-9FD2-FFD4FA3EF737}" dt="2024-05-02T15:22:57.398" v="5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114BE5A3-0B0D-440B-9FD2-FFD4FA3EF737}" dt="2024-05-02T15:22:54.759" v="3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114BE5A3-0B0D-440B-9FD2-FFD4FA3EF737}" dt="2024-05-02T15:22:52.621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114BE5A3-0B0D-440B-9FD2-FFD4FA3EF737}" dt="2024-05-02T15:22:53.383" v="1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114BE5A3-0B0D-440B-9FD2-FFD4FA3EF737}" dt="2024-05-02T15:22:54.020" v="2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114BE5A3-0B0D-440B-9FD2-FFD4FA3EF737}" dt="2024-05-02T15:22:56.914" v="4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114BE5A3-0B0D-440B-9FD2-FFD4FA3EF737}" dt="2024-05-02T15:22:58.220" v="7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114BE5A3-0B0D-440B-9FD2-FFD4FA3EF737}" dt="2024-05-02T15:22:57.880" v="6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87 up genes (including Ccl6, Ccl9, </a:t>
            </a:r>
            <a:r>
              <a:rPr lang="en-US" b="0" i="0">
                <a:solidFill>
                  <a:srgbClr val="111111"/>
                </a:solidFill>
                <a:effectLst/>
                <a:latin typeface="Roboto" panose="02000000000000000000" pitchFamily="2" charset="0"/>
              </a:rPr>
              <a:t>Angiopoietin</a:t>
            </a:r>
            <a:endParaRPr lang="en-US"/>
          </a:p>
          <a:p>
            <a:r>
              <a:rPr lang="en-US"/>
              <a:t>Ccr2, Ccr5, Cd44, Cd53, Mrc1, Stat3,etc …)</a:t>
            </a:r>
          </a:p>
          <a:p>
            <a:r>
              <a:rPr lang="en-US"/>
              <a:t>12 down genes (including Spp1)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04CE70-8047-4961-A4E1-7E2EBE4BCA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412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8B26B0A1-193E-1AA7-0B61-2E36CE0C17BE}"/>
              </a:ext>
            </a:extLst>
          </p:cNvPr>
          <p:cNvSpPr txBox="1"/>
          <p:nvPr/>
        </p:nvSpPr>
        <p:spPr>
          <a:xfrm>
            <a:off x="4050451" y="83628"/>
            <a:ext cx="1235789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100"/>
              <a:t>Interaction strengt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1969F08-2D93-54A1-BCD0-6F59506E5098}"/>
              </a:ext>
            </a:extLst>
          </p:cNvPr>
          <p:cNvSpPr txBox="1"/>
          <p:nvPr/>
        </p:nvSpPr>
        <p:spPr>
          <a:xfrm>
            <a:off x="6229896" y="1059238"/>
            <a:ext cx="46653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/>
              <a:t>myCAF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DAD72164-33AA-AC8D-C9EE-3B19EFCDD7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9628" y="361508"/>
            <a:ext cx="914400" cy="9144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63B5F78-E820-8A47-AD61-8D0450D4A9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2785" y="1133908"/>
            <a:ext cx="914400" cy="9144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BAB2788-53D8-3C33-F8F1-B303853F4C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00871" y="361508"/>
            <a:ext cx="914400" cy="9144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E299327-6A82-773E-7B1A-CCDA25C0A3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00871" y="1133908"/>
            <a:ext cx="914400" cy="9144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430B5E1-D375-0D5A-57FD-8104EABE8D3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13736" y="361508"/>
            <a:ext cx="914400" cy="9144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C034348-6001-19D3-3DCE-5CFC047001C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13736" y="1133908"/>
            <a:ext cx="914400" cy="9144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89884CD8-D60C-E993-17B2-7887A710CE8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52784" y="2010193"/>
            <a:ext cx="914400" cy="9144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C454263D-9F86-13EA-51FB-E05A980CA34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52784" y="2870056"/>
            <a:ext cx="914400" cy="9144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1026A5B3-2590-C418-7DDC-0C36D1A3C75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39691" y="2010193"/>
            <a:ext cx="914400" cy="9144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F32E1DFD-E7B0-AD81-01D2-2A67E69AF4D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39691" y="2870056"/>
            <a:ext cx="914400" cy="9144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F26E4365-3B9E-5F72-1621-508CBF0BE68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381876" y="2010193"/>
            <a:ext cx="914400" cy="9144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1F81C7F3-FB25-9796-15AE-A903B601C06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381876" y="2870056"/>
            <a:ext cx="914400" cy="9144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56798FF3-C5C1-28D9-F0FE-9A5127FFFE9A}"/>
              </a:ext>
            </a:extLst>
          </p:cNvPr>
          <p:cNvSpPr txBox="1"/>
          <p:nvPr/>
        </p:nvSpPr>
        <p:spPr>
          <a:xfrm>
            <a:off x="3828243" y="283900"/>
            <a:ext cx="19717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/>
              <a:t>TC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AEEF3B5-2E75-CB48-0867-0F1C71402C0D}"/>
              </a:ext>
            </a:extLst>
          </p:cNvPr>
          <p:cNvSpPr txBox="1"/>
          <p:nvPr/>
        </p:nvSpPr>
        <p:spPr>
          <a:xfrm>
            <a:off x="4759486" y="283900"/>
            <a:ext cx="19717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/>
              <a:t>TC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5220480-BC02-A819-1B83-1099702A3646}"/>
              </a:ext>
            </a:extLst>
          </p:cNvPr>
          <p:cNvSpPr txBox="1"/>
          <p:nvPr/>
        </p:nvSpPr>
        <p:spPr>
          <a:xfrm>
            <a:off x="5672351" y="283900"/>
            <a:ext cx="19717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/>
              <a:t>TC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A14D579-A82F-09E5-EB2B-46A49312D8FF}"/>
              </a:ext>
            </a:extLst>
          </p:cNvPr>
          <p:cNvSpPr txBox="1"/>
          <p:nvPr/>
        </p:nvSpPr>
        <p:spPr>
          <a:xfrm rot="16200000">
            <a:off x="3133204" y="702709"/>
            <a:ext cx="35907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>
                <a:solidFill>
                  <a:srgbClr val="0000FF"/>
                </a:solidFill>
              </a:rPr>
              <a:t>Vehicl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35C21AC-5D1C-8469-E08B-7D6408BCE778}"/>
              </a:ext>
            </a:extLst>
          </p:cNvPr>
          <p:cNvSpPr txBox="1"/>
          <p:nvPr/>
        </p:nvSpPr>
        <p:spPr>
          <a:xfrm rot="16200000">
            <a:off x="3029010" y="1521859"/>
            <a:ext cx="56746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SOS1i+MEKi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7219529-FCEF-D49E-C63A-492C2857EF0A}"/>
              </a:ext>
            </a:extLst>
          </p:cNvPr>
          <p:cNvSpPr txBox="1"/>
          <p:nvPr/>
        </p:nvSpPr>
        <p:spPr>
          <a:xfrm>
            <a:off x="6229896" y="2747264"/>
            <a:ext cx="431208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/>
              <a:t>apCAF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3A510E0-50F9-1C72-ECE0-3361897AFA91}"/>
              </a:ext>
            </a:extLst>
          </p:cNvPr>
          <p:cNvSpPr txBox="1"/>
          <p:nvPr/>
        </p:nvSpPr>
        <p:spPr>
          <a:xfrm rot="16200000">
            <a:off x="3133203" y="2404510"/>
            <a:ext cx="35907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>
                <a:solidFill>
                  <a:srgbClr val="0000FF"/>
                </a:solidFill>
              </a:rPr>
              <a:t>Vehicl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9F4877B-4EA9-D8CC-9B61-54DD9BBC55DA}"/>
              </a:ext>
            </a:extLst>
          </p:cNvPr>
          <p:cNvSpPr txBox="1"/>
          <p:nvPr/>
        </p:nvSpPr>
        <p:spPr>
          <a:xfrm rot="16200000">
            <a:off x="3029009" y="3223660"/>
            <a:ext cx="56746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SOS1i+MEKi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6192925E-0133-33D0-A9C4-322F00B58980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r="16565"/>
          <a:stretch/>
        </p:blipFill>
        <p:spPr>
          <a:xfrm>
            <a:off x="374406" y="4292559"/>
            <a:ext cx="3411302" cy="3477538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3752CB7B-B9AC-F324-6EC7-94AA7D6CD97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251831" y="4205037"/>
            <a:ext cx="1563369" cy="1441942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9C8F75B7-63FB-1DB4-A10E-720BD3017FD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739783" y="5799172"/>
            <a:ext cx="2041006" cy="1733457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3A396094-7E33-85CC-307E-6F783B674FB0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82957" t="28507" b="40463"/>
          <a:stretch/>
        </p:blipFill>
        <p:spPr>
          <a:xfrm>
            <a:off x="4118211" y="6031328"/>
            <a:ext cx="784801" cy="1215343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3656C4F4-1EBD-EFE6-1132-8692DBE3F86E}"/>
              </a:ext>
            </a:extLst>
          </p:cNvPr>
          <p:cNvSpPr txBox="1"/>
          <p:nvPr/>
        </p:nvSpPr>
        <p:spPr>
          <a:xfrm>
            <a:off x="2939086" y="256599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/>
              <a:t>B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7425108-2699-61FC-64EB-8F7804F9AAFB}"/>
              </a:ext>
            </a:extLst>
          </p:cNvPr>
          <p:cNvSpPr txBox="1"/>
          <p:nvPr/>
        </p:nvSpPr>
        <p:spPr>
          <a:xfrm>
            <a:off x="161566" y="4026797"/>
            <a:ext cx="11702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/>
              <a:t>C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E5F4D55-1BF1-61E9-0DB5-E3039500A724}"/>
              </a:ext>
            </a:extLst>
          </p:cNvPr>
          <p:cNvSpPr txBox="1"/>
          <p:nvPr/>
        </p:nvSpPr>
        <p:spPr>
          <a:xfrm>
            <a:off x="3926828" y="3940043"/>
            <a:ext cx="12503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1F51400-02A3-EE9F-3901-4FC0B0CF38E0}"/>
              </a:ext>
            </a:extLst>
          </p:cNvPr>
          <p:cNvSpPr txBox="1"/>
          <p:nvPr/>
        </p:nvSpPr>
        <p:spPr>
          <a:xfrm>
            <a:off x="1744709" y="4112704"/>
            <a:ext cx="1408527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err="1"/>
              <a:t>iCAF</a:t>
            </a:r>
            <a:r>
              <a:rPr lang="en-US" sz="1200"/>
              <a:t> -&gt; macrophag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E7ACF6F-43C4-4941-DFBA-149B71F1508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43005" y="472043"/>
            <a:ext cx="1458650" cy="113450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4750AE1-8E53-0D2E-0DBD-490B28BBA6B7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08022" y="1575423"/>
            <a:ext cx="2025990" cy="106494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EF415C1-F47B-088B-2456-82EB8ED12C9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30743" y="2617497"/>
            <a:ext cx="1605274" cy="13270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8F2302C-F10C-9FF1-1AD1-C0FD048DF2AF}"/>
              </a:ext>
            </a:extLst>
          </p:cNvPr>
          <p:cNvSpPr txBox="1"/>
          <p:nvPr/>
        </p:nvSpPr>
        <p:spPr>
          <a:xfrm>
            <a:off x="159054" y="282786"/>
            <a:ext cx="11702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b="1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E685D2-444D-24FF-F807-7D7C2E534779}"/>
              </a:ext>
            </a:extLst>
          </p:cNvPr>
          <p:cNvSpPr txBox="1"/>
          <p:nvPr/>
        </p:nvSpPr>
        <p:spPr>
          <a:xfrm>
            <a:off x="264172" y="7971684"/>
            <a:ext cx="609692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eat map of relative average expression of strongly enriched genes for each subset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action strength centered around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yCAF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Top) and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CAF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ottom) before and after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S1i+MEKi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igand-receptor interactions between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CAFs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macrophages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rosstalk pathways upregulated and downregulated between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CAF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macrophages before and after SOS1i+MEKi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50AF0450-9DF8-17F3-3C4A-E79FB528C04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022191" y="4339988"/>
            <a:ext cx="1382025" cy="1274683"/>
          </a:xfrm>
          <a:prstGeom prst="rect">
            <a:avLst/>
          </a:prstGeom>
        </p:spPr>
      </p:pic>
      <p:sp>
        <p:nvSpPr>
          <p:cNvPr id="8" name="Title 2">
            <a:extLst>
              <a:ext uri="{FF2B5EF4-FFF2-40B4-BE49-F238E27FC236}">
                <a16:creationId xmlns:a16="http://schemas.microsoft.com/office/drawing/2014/main" id="{399BD378-93EC-CEBA-57C0-48759D2F6919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1104710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Props1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</TotalTime>
  <Words>126</Words>
  <Application>Microsoft Office PowerPoint</Application>
  <PresentationFormat>Letter Paper (8.5x11 in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Roboto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3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